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DDF45-FB37-44D5-98F0-16BF3EA8B76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793769-3C3F-4650-A5C1-DDA620C7FE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6021CA-5100-4B57-8F8C-5592C7CF22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969101-726F-48E3-9D24-CFCDF08B47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B0179A-DB74-4D1F-A133-9B007842DC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427E1-E931-4C72-964D-86F7646043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F4823-9A95-42BF-90C9-AF5B11684D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DFBDE3-4A2F-4239-82D1-FD26892D0D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328BB6-8A08-4424-B29E-1FBCD11BD0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D1F78-F233-42FD-8165-A04C14CFE3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1B8990-53D1-4C45-9AC9-1868E3724B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6B51BE-8C82-4D92-BE8F-30B2C50C95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1F2D68-B4F3-4B45-97C5-7DCBFD37E02F}" type="slidenum">
              <a:rPr b="0" lang="fr-FR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083000" y="6477120"/>
            <a:ext cx="1983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Arial"/>
              </a:rPr>
              <a:t>Supplementary Fig. 8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52280" y="1015920"/>
            <a:ext cx="8869680" cy="5034960"/>
            <a:chOff x="152280" y="1015920"/>
            <a:chExt cx="8869680" cy="5034960"/>
          </a:xfrm>
        </p:grpSpPr>
        <p:sp>
          <p:nvSpPr>
            <p:cNvPr id="43" name=""/>
            <p:cNvSpPr/>
            <p:nvPr/>
          </p:nvSpPr>
          <p:spPr>
            <a:xfrm>
              <a:off x="1050840" y="1116000"/>
              <a:ext cx="1800" cy="4206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009800" y="5322960"/>
              <a:ext cx="41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009800" y="4795920"/>
              <a:ext cx="41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009800" y="4270320"/>
              <a:ext cx="410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009800" y="3745080"/>
              <a:ext cx="41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009800" y="3219480"/>
              <a:ext cx="41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1009800" y="2693880"/>
              <a:ext cx="4104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009800" y="2168640"/>
              <a:ext cx="41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1009800" y="1643040"/>
              <a:ext cx="41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1009800" y="1116000"/>
              <a:ext cx="4104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050840" y="5322960"/>
              <a:ext cx="76122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 flipV="1">
              <a:off x="1050840" y="5322960"/>
              <a:ext cx="1800" cy="41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 flipV="1">
              <a:off x="2319480" y="5322960"/>
              <a:ext cx="1440" cy="41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 flipV="1">
              <a:off x="3587760" y="5322960"/>
              <a:ext cx="1440" cy="41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 flipV="1">
              <a:off x="4857840" y="5322960"/>
              <a:ext cx="1440" cy="41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 flipV="1">
              <a:off x="6126120" y="5322960"/>
              <a:ext cx="1800" cy="41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 flipV="1">
              <a:off x="7394400" y="5322960"/>
              <a:ext cx="1800" cy="41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 flipV="1">
              <a:off x="8663040" y="5322960"/>
              <a:ext cx="1440" cy="41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5760" bIns="-57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974880" y="1170000"/>
              <a:ext cx="7292880" cy="3735360"/>
            </a:xfrm>
            <a:custGeom>
              <a:avLst/>
              <a:gdLst/>
              <a:ahLst/>
              <a:rect l="l" t="t" r="r" b="b"/>
              <a:pathLst>
                <a:path w="4594" h="2353">
                  <a:moveTo>
                    <a:pt x="0" y="621"/>
                  </a:moveTo>
                  <a:lnTo>
                    <a:pt x="20" y="617"/>
                  </a:lnTo>
                  <a:lnTo>
                    <a:pt x="40" y="709"/>
                  </a:lnTo>
                  <a:lnTo>
                    <a:pt x="59" y="741"/>
                  </a:lnTo>
                  <a:lnTo>
                    <a:pt x="79" y="715"/>
                  </a:lnTo>
                  <a:lnTo>
                    <a:pt x="99" y="715"/>
                  </a:lnTo>
                  <a:lnTo>
                    <a:pt x="120" y="693"/>
                  </a:lnTo>
                  <a:lnTo>
                    <a:pt x="140" y="721"/>
                  </a:lnTo>
                  <a:lnTo>
                    <a:pt x="159" y="692"/>
                  </a:lnTo>
                  <a:lnTo>
                    <a:pt x="179" y="698"/>
                  </a:lnTo>
                  <a:lnTo>
                    <a:pt x="199" y="738"/>
                  </a:lnTo>
                  <a:lnTo>
                    <a:pt x="219" y="720"/>
                  </a:lnTo>
                  <a:lnTo>
                    <a:pt x="240" y="719"/>
                  </a:lnTo>
                  <a:lnTo>
                    <a:pt x="259" y="711"/>
                  </a:lnTo>
                  <a:lnTo>
                    <a:pt x="279" y="729"/>
                  </a:lnTo>
                  <a:lnTo>
                    <a:pt x="299" y="762"/>
                  </a:lnTo>
                  <a:lnTo>
                    <a:pt x="319" y="778"/>
                  </a:lnTo>
                  <a:lnTo>
                    <a:pt x="339" y="799"/>
                  </a:lnTo>
                  <a:lnTo>
                    <a:pt x="359" y="801"/>
                  </a:lnTo>
                  <a:lnTo>
                    <a:pt x="379" y="821"/>
                  </a:lnTo>
                  <a:lnTo>
                    <a:pt x="399" y="807"/>
                  </a:lnTo>
                  <a:lnTo>
                    <a:pt x="419" y="817"/>
                  </a:lnTo>
                  <a:lnTo>
                    <a:pt x="439" y="747"/>
                  </a:lnTo>
                  <a:lnTo>
                    <a:pt x="459" y="778"/>
                  </a:lnTo>
                  <a:lnTo>
                    <a:pt x="479" y="793"/>
                  </a:lnTo>
                  <a:lnTo>
                    <a:pt x="499" y="820"/>
                  </a:lnTo>
                  <a:lnTo>
                    <a:pt x="519" y="826"/>
                  </a:lnTo>
                  <a:lnTo>
                    <a:pt x="539" y="854"/>
                  </a:lnTo>
                  <a:lnTo>
                    <a:pt x="559" y="884"/>
                  </a:lnTo>
                  <a:lnTo>
                    <a:pt x="579" y="913"/>
                  </a:lnTo>
                  <a:lnTo>
                    <a:pt x="599" y="912"/>
                  </a:lnTo>
                  <a:lnTo>
                    <a:pt x="619" y="918"/>
                  </a:lnTo>
                  <a:lnTo>
                    <a:pt x="639" y="961"/>
                  </a:lnTo>
                  <a:lnTo>
                    <a:pt x="659" y="975"/>
                  </a:lnTo>
                  <a:lnTo>
                    <a:pt x="678" y="982"/>
                  </a:lnTo>
                  <a:lnTo>
                    <a:pt x="699" y="989"/>
                  </a:lnTo>
                  <a:lnTo>
                    <a:pt x="719" y="986"/>
                  </a:lnTo>
                  <a:lnTo>
                    <a:pt x="739" y="960"/>
                  </a:lnTo>
                  <a:lnTo>
                    <a:pt x="759" y="990"/>
                  </a:lnTo>
                  <a:lnTo>
                    <a:pt x="778" y="997"/>
                  </a:lnTo>
                  <a:lnTo>
                    <a:pt x="798" y="953"/>
                  </a:lnTo>
                  <a:lnTo>
                    <a:pt x="819" y="955"/>
                  </a:lnTo>
                  <a:lnTo>
                    <a:pt x="839" y="984"/>
                  </a:lnTo>
                  <a:lnTo>
                    <a:pt x="859" y="969"/>
                  </a:lnTo>
                  <a:lnTo>
                    <a:pt x="878" y="1014"/>
                  </a:lnTo>
                  <a:lnTo>
                    <a:pt x="898" y="1022"/>
                  </a:lnTo>
                  <a:lnTo>
                    <a:pt x="919" y="1038"/>
                  </a:lnTo>
                  <a:lnTo>
                    <a:pt x="939" y="1072"/>
                  </a:lnTo>
                  <a:lnTo>
                    <a:pt x="959" y="1126"/>
                  </a:lnTo>
                  <a:lnTo>
                    <a:pt x="978" y="1209"/>
                  </a:lnTo>
                  <a:lnTo>
                    <a:pt x="998" y="1233"/>
                  </a:lnTo>
                  <a:lnTo>
                    <a:pt x="1018" y="1234"/>
                  </a:lnTo>
                  <a:lnTo>
                    <a:pt x="1039" y="1195"/>
                  </a:lnTo>
                  <a:lnTo>
                    <a:pt x="1059" y="1197"/>
                  </a:lnTo>
                  <a:lnTo>
                    <a:pt x="1078" y="1202"/>
                  </a:lnTo>
                  <a:lnTo>
                    <a:pt x="1098" y="1192"/>
                  </a:lnTo>
                  <a:lnTo>
                    <a:pt x="1118" y="1192"/>
                  </a:lnTo>
                  <a:lnTo>
                    <a:pt x="1138" y="1174"/>
                  </a:lnTo>
                  <a:lnTo>
                    <a:pt x="1159" y="1168"/>
                  </a:lnTo>
                  <a:lnTo>
                    <a:pt x="1178" y="1178"/>
                  </a:lnTo>
                  <a:lnTo>
                    <a:pt x="1198" y="1187"/>
                  </a:lnTo>
                  <a:lnTo>
                    <a:pt x="1218" y="1199"/>
                  </a:lnTo>
                  <a:lnTo>
                    <a:pt x="1238" y="1219"/>
                  </a:lnTo>
                  <a:lnTo>
                    <a:pt x="1258" y="1209"/>
                  </a:lnTo>
                  <a:lnTo>
                    <a:pt x="1278" y="1154"/>
                  </a:lnTo>
                  <a:lnTo>
                    <a:pt x="1298" y="1172"/>
                  </a:lnTo>
                  <a:lnTo>
                    <a:pt x="1318" y="1207"/>
                  </a:lnTo>
                  <a:lnTo>
                    <a:pt x="1338" y="1232"/>
                  </a:lnTo>
                  <a:lnTo>
                    <a:pt x="1358" y="1195"/>
                  </a:lnTo>
                  <a:lnTo>
                    <a:pt x="1377" y="1142"/>
                  </a:lnTo>
                  <a:lnTo>
                    <a:pt x="1398" y="1107"/>
                  </a:lnTo>
                  <a:lnTo>
                    <a:pt x="1418" y="1117"/>
                  </a:lnTo>
                  <a:lnTo>
                    <a:pt x="1438" y="1097"/>
                  </a:lnTo>
                  <a:lnTo>
                    <a:pt x="1458" y="1118"/>
                  </a:lnTo>
                  <a:lnTo>
                    <a:pt x="1477" y="1109"/>
                  </a:lnTo>
                  <a:lnTo>
                    <a:pt x="1498" y="1106"/>
                  </a:lnTo>
                  <a:lnTo>
                    <a:pt x="1518" y="1093"/>
                  </a:lnTo>
                  <a:lnTo>
                    <a:pt x="1538" y="1095"/>
                  </a:lnTo>
                  <a:lnTo>
                    <a:pt x="1558" y="1063"/>
                  </a:lnTo>
                  <a:lnTo>
                    <a:pt x="1578" y="1046"/>
                  </a:lnTo>
                  <a:lnTo>
                    <a:pt x="1597" y="1058"/>
                  </a:lnTo>
                  <a:lnTo>
                    <a:pt x="1618" y="1049"/>
                  </a:lnTo>
                  <a:lnTo>
                    <a:pt x="1638" y="1027"/>
                  </a:lnTo>
                  <a:lnTo>
                    <a:pt x="1658" y="1037"/>
                  </a:lnTo>
                  <a:lnTo>
                    <a:pt x="1678" y="1084"/>
                  </a:lnTo>
                  <a:lnTo>
                    <a:pt x="1697" y="1080"/>
                  </a:lnTo>
                  <a:lnTo>
                    <a:pt x="1717" y="1041"/>
                  </a:lnTo>
                  <a:lnTo>
                    <a:pt x="1738" y="993"/>
                  </a:lnTo>
                  <a:lnTo>
                    <a:pt x="1758" y="989"/>
                  </a:lnTo>
                  <a:lnTo>
                    <a:pt x="1778" y="960"/>
                  </a:lnTo>
                  <a:lnTo>
                    <a:pt x="1797" y="1027"/>
                  </a:lnTo>
                  <a:lnTo>
                    <a:pt x="1817" y="1051"/>
                  </a:lnTo>
                  <a:lnTo>
                    <a:pt x="1837" y="1055"/>
                  </a:lnTo>
                  <a:lnTo>
                    <a:pt x="1858" y="1067"/>
                  </a:lnTo>
                  <a:lnTo>
                    <a:pt x="1878" y="1104"/>
                  </a:lnTo>
                  <a:lnTo>
                    <a:pt x="1897" y="1154"/>
                  </a:lnTo>
                  <a:lnTo>
                    <a:pt x="1917" y="1149"/>
                  </a:lnTo>
                  <a:lnTo>
                    <a:pt x="1937" y="1175"/>
                  </a:lnTo>
                  <a:lnTo>
                    <a:pt x="1957" y="1177"/>
                  </a:lnTo>
                  <a:lnTo>
                    <a:pt x="1978" y="1204"/>
                  </a:lnTo>
                  <a:lnTo>
                    <a:pt x="1997" y="1179"/>
                  </a:lnTo>
                  <a:lnTo>
                    <a:pt x="2017" y="1171"/>
                  </a:lnTo>
                  <a:lnTo>
                    <a:pt x="2037" y="1202"/>
                  </a:lnTo>
                  <a:lnTo>
                    <a:pt x="2057" y="1217"/>
                  </a:lnTo>
                  <a:lnTo>
                    <a:pt x="2077" y="1187"/>
                  </a:lnTo>
                  <a:lnTo>
                    <a:pt x="2097" y="1156"/>
                  </a:lnTo>
                  <a:lnTo>
                    <a:pt x="2117" y="1162"/>
                  </a:lnTo>
                  <a:lnTo>
                    <a:pt x="2137" y="1272"/>
                  </a:lnTo>
                  <a:lnTo>
                    <a:pt x="2157" y="1352"/>
                  </a:lnTo>
                  <a:lnTo>
                    <a:pt x="2177" y="1342"/>
                  </a:lnTo>
                  <a:lnTo>
                    <a:pt x="2197" y="1280"/>
                  </a:lnTo>
                  <a:lnTo>
                    <a:pt x="2217" y="1296"/>
                  </a:lnTo>
                  <a:lnTo>
                    <a:pt x="2237" y="1300"/>
                  </a:lnTo>
                  <a:lnTo>
                    <a:pt x="2257" y="1327"/>
                  </a:lnTo>
                  <a:lnTo>
                    <a:pt x="2277" y="1346"/>
                  </a:lnTo>
                  <a:lnTo>
                    <a:pt x="2296" y="1322"/>
                  </a:lnTo>
                  <a:lnTo>
                    <a:pt x="2317" y="1338"/>
                  </a:lnTo>
                  <a:lnTo>
                    <a:pt x="2337" y="1345"/>
                  </a:lnTo>
                  <a:lnTo>
                    <a:pt x="2357" y="1362"/>
                  </a:lnTo>
                  <a:lnTo>
                    <a:pt x="2377" y="1409"/>
                  </a:lnTo>
                  <a:lnTo>
                    <a:pt x="2396" y="1405"/>
                  </a:lnTo>
                  <a:lnTo>
                    <a:pt x="2416" y="1419"/>
                  </a:lnTo>
                  <a:lnTo>
                    <a:pt x="2437" y="1417"/>
                  </a:lnTo>
                  <a:lnTo>
                    <a:pt x="2457" y="1437"/>
                  </a:lnTo>
                  <a:lnTo>
                    <a:pt x="2477" y="1470"/>
                  </a:lnTo>
                  <a:lnTo>
                    <a:pt x="2497" y="1517"/>
                  </a:lnTo>
                  <a:lnTo>
                    <a:pt x="2516" y="1462"/>
                  </a:lnTo>
                  <a:lnTo>
                    <a:pt x="2536" y="1371"/>
                  </a:lnTo>
                  <a:lnTo>
                    <a:pt x="2557" y="1298"/>
                  </a:lnTo>
                  <a:lnTo>
                    <a:pt x="2577" y="1282"/>
                  </a:lnTo>
                  <a:lnTo>
                    <a:pt x="2597" y="1282"/>
                  </a:lnTo>
                  <a:lnTo>
                    <a:pt x="2616" y="1323"/>
                  </a:lnTo>
                  <a:lnTo>
                    <a:pt x="2636" y="1351"/>
                  </a:lnTo>
                  <a:lnTo>
                    <a:pt x="2657" y="1379"/>
                  </a:lnTo>
                  <a:lnTo>
                    <a:pt x="2677" y="1383"/>
                  </a:lnTo>
                  <a:lnTo>
                    <a:pt x="2697" y="1436"/>
                  </a:lnTo>
                  <a:lnTo>
                    <a:pt x="2716" y="1492"/>
                  </a:lnTo>
                  <a:lnTo>
                    <a:pt x="2736" y="1517"/>
                  </a:lnTo>
                  <a:lnTo>
                    <a:pt x="2756" y="1596"/>
                  </a:lnTo>
                  <a:lnTo>
                    <a:pt x="2777" y="1619"/>
                  </a:lnTo>
                  <a:lnTo>
                    <a:pt x="2797" y="1684"/>
                  </a:lnTo>
                  <a:lnTo>
                    <a:pt x="2816" y="1719"/>
                  </a:lnTo>
                  <a:lnTo>
                    <a:pt x="2836" y="1679"/>
                  </a:lnTo>
                  <a:lnTo>
                    <a:pt x="2856" y="1652"/>
                  </a:lnTo>
                  <a:lnTo>
                    <a:pt x="2876" y="1597"/>
                  </a:lnTo>
                  <a:lnTo>
                    <a:pt x="2897" y="1611"/>
                  </a:lnTo>
                  <a:lnTo>
                    <a:pt x="2916" y="1712"/>
                  </a:lnTo>
                  <a:lnTo>
                    <a:pt x="2936" y="1736"/>
                  </a:lnTo>
                  <a:lnTo>
                    <a:pt x="2956" y="1771"/>
                  </a:lnTo>
                  <a:lnTo>
                    <a:pt x="2976" y="1773"/>
                  </a:lnTo>
                  <a:lnTo>
                    <a:pt x="2996" y="1766"/>
                  </a:lnTo>
                  <a:lnTo>
                    <a:pt x="3016" y="1739"/>
                  </a:lnTo>
                  <a:lnTo>
                    <a:pt x="3036" y="1677"/>
                  </a:lnTo>
                  <a:lnTo>
                    <a:pt x="3056" y="1714"/>
                  </a:lnTo>
                  <a:lnTo>
                    <a:pt x="3076" y="1736"/>
                  </a:lnTo>
                  <a:lnTo>
                    <a:pt x="3096" y="1760"/>
                  </a:lnTo>
                  <a:lnTo>
                    <a:pt x="3115" y="1762"/>
                  </a:lnTo>
                  <a:lnTo>
                    <a:pt x="3136" y="1790"/>
                  </a:lnTo>
                  <a:lnTo>
                    <a:pt x="3156" y="1819"/>
                  </a:lnTo>
                  <a:lnTo>
                    <a:pt x="3176" y="1921"/>
                  </a:lnTo>
                  <a:lnTo>
                    <a:pt x="3196" y="2049"/>
                  </a:lnTo>
                  <a:lnTo>
                    <a:pt x="3215" y="2047"/>
                  </a:lnTo>
                  <a:lnTo>
                    <a:pt x="3236" y="2122"/>
                  </a:lnTo>
                  <a:lnTo>
                    <a:pt x="3256" y="2211"/>
                  </a:lnTo>
                  <a:lnTo>
                    <a:pt x="3276" y="2299"/>
                  </a:lnTo>
                  <a:lnTo>
                    <a:pt x="3296" y="2353"/>
                  </a:lnTo>
                  <a:lnTo>
                    <a:pt x="3315" y="2332"/>
                  </a:lnTo>
                  <a:lnTo>
                    <a:pt x="3335" y="2288"/>
                  </a:lnTo>
                  <a:lnTo>
                    <a:pt x="3356" y="2289"/>
                  </a:lnTo>
                  <a:lnTo>
                    <a:pt x="3376" y="2276"/>
                  </a:lnTo>
                  <a:lnTo>
                    <a:pt x="3396" y="2298"/>
                  </a:lnTo>
                  <a:lnTo>
                    <a:pt x="3416" y="2283"/>
                  </a:lnTo>
                  <a:lnTo>
                    <a:pt x="3435" y="2349"/>
                  </a:lnTo>
                  <a:lnTo>
                    <a:pt x="3455" y="2296"/>
                  </a:lnTo>
                  <a:lnTo>
                    <a:pt x="3476" y="2294"/>
                  </a:lnTo>
                  <a:lnTo>
                    <a:pt x="3496" y="2257"/>
                  </a:lnTo>
                  <a:lnTo>
                    <a:pt x="3516" y="2263"/>
                  </a:lnTo>
                  <a:lnTo>
                    <a:pt x="3535" y="2210"/>
                  </a:lnTo>
                  <a:lnTo>
                    <a:pt x="3555" y="2112"/>
                  </a:lnTo>
                  <a:lnTo>
                    <a:pt x="3575" y="2000"/>
                  </a:lnTo>
                  <a:lnTo>
                    <a:pt x="3596" y="1796"/>
                  </a:lnTo>
                  <a:lnTo>
                    <a:pt x="3616" y="1760"/>
                  </a:lnTo>
                  <a:lnTo>
                    <a:pt x="3635" y="1673"/>
                  </a:lnTo>
                  <a:lnTo>
                    <a:pt x="3655" y="1563"/>
                  </a:lnTo>
                  <a:lnTo>
                    <a:pt x="3675" y="1397"/>
                  </a:lnTo>
                  <a:lnTo>
                    <a:pt x="3695" y="1181"/>
                  </a:lnTo>
                  <a:lnTo>
                    <a:pt x="3716" y="1080"/>
                  </a:lnTo>
                  <a:lnTo>
                    <a:pt x="3735" y="1057"/>
                  </a:lnTo>
                  <a:lnTo>
                    <a:pt x="3755" y="1018"/>
                  </a:lnTo>
                  <a:lnTo>
                    <a:pt x="3775" y="1024"/>
                  </a:lnTo>
                  <a:lnTo>
                    <a:pt x="3795" y="982"/>
                  </a:lnTo>
                  <a:lnTo>
                    <a:pt x="3815" y="961"/>
                  </a:lnTo>
                  <a:lnTo>
                    <a:pt x="3835" y="927"/>
                  </a:lnTo>
                  <a:lnTo>
                    <a:pt x="3855" y="931"/>
                  </a:lnTo>
                  <a:lnTo>
                    <a:pt x="3875" y="819"/>
                  </a:lnTo>
                  <a:lnTo>
                    <a:pt x="3895" y="640"/>
                  </a:lnTo>
                  <a:lnTo>
                    <a:pt x="3915" y="513"/>
                  </a:lnTo>
                  <a:lnTo>
                    <a:pt x="3935" y="450"/>
                  </a:lnTo>
                  <a:lnTo>
                    <a:pt x="3955" y="446"/>
                  </a:lnTo>
                  <a:lnTo>
                    <a:pt x="3975" y="410"/>
                  </a:lnTo>
                  <a:lnTo>
                    <a:pt x="3995" y="316"/>
                  </a:lnTo>
                  <a:lnTo>
                    <a:pt x="4015" y="300"/>
                  </a:lnTo>
                  <a:lnTo>
                    <a:pt x="4034" y="286"/>
                  </a:lnTo>
                  <a:lnTo>
                    <a:pt x="4055" y="244"/>
                  </a:lnTo>
                  <a:lnTo>
                    <a:pt x="4075" y="222"/>
                  </a:lnTo>
                  <a:lnTo>
                    <a:pt x="4095" y="198"/>
                  </a:lnTo>
                  <a:lnTo>
                    <a:pt x="4115" y="138"/>
                  </a:lnTo>
                  <a:lnTo>
                    <a:pt x="4134" y="117"/>
                  </a:lnTo>
                  <a:lnTo>
                    <a:pt x="4154" y="83"/>
                  </a:lnTo>
                  <a:lnTo>
                    <a:pt x="4175" y="74"/>
                  </a:lnTo>
                  <a:lnTo>
                    <a:pt x="4195" y="49"/>
                  </a:lnTo>
                  <a:lnTo>
                    <a:pt x="4215" y="36"/>
                  </a:lnTo>
                  <a:lnTo>
                    <a:pt x="4234" y="37"/>
                  </a:lnTo>
                  <a:lnTo>
                    <a:pt x="4254" y="0"/>
                  </a:lnTo>
                  <a:lnTo>
                    <a:pt x="4274" y="113"/>
                  </a:lnTo>
                  <a:lnTo>
                    <a:pt x="4295" y="238"/>
                  </a:lnTo>
                  <a:lnTo>
                    <a:pt x="4315" y="327"/>
                  </a:lnTo>
                  <a:lnTo>
                    <a:pt x="4334" y="337"/>
                  </a:lnTo>
                  <a:lnTo>
                    <a:pt x="4354" y="373"/>
                  </a:lnTo>
                  <a:lnTo>
                    <a:pt x="4374" y="382"/>
                  </a:lnTo>
                  <a:lnTo>
                    <a:pt x="4395" y="436"/>
                  </a:lnTo>
                  <a:lnTo>
                    <a:pt x="4415" y="476"/>
                  </a:lnTo>
                  <a:lnTo>
                    <a:pt x="4435" y="510"/>
                  </a:lnTo>
                  <a:lnTo>
                    <a:pt x="4454" y="533"/>
                  </a:lnTo>
                  <a:lnTo>
                    <a:pt x="4474" y="574"/>
                  </a:lnTo>
                  <a:lnTo>
                    <a:pt x="4494" y="570"/>
                  </a:lnTo>
                  <a:lnTo>
                    <a:pt x="4515" y="645"/>
                  </a:lnTo>
                  <a:lnTo>
                    <a:pt x="4535" y="672"/>
                  </a:lnTo>
                  <a:lnTo>
                    <a:pt x="4554" y="699"/>
                  </a:lnTo>
                  <a:lnTo>
                    <a:pt x="4574" y="699"/>
                  </a:lnTo>
                  <a:lnTo>
                    <a:pt x="4594" y="723"/>
                  </a:lnTo>
                </a:path>
              </a:pathLst>
            </a:custGeom>
            <a:noFill/>
            <a:ln w="237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738360" y="5221440"/>
              <a:ext cx="221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12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38360" y="4695840"/>
              <a:ext cx="2217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1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808920" y="4170240"/>
              <a:ext cx="136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8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808920" y="3643200"/>
              <a:ext cx="136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6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808920" y="3119400"/>
              <a:ext cx="136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4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808920" y="2593800"/>
              <a:ext cx="1364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2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856440" y="206856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856440" y="15415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856440" y="101592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749160" y="5411880"/>
              <a:ext cx="66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08E+06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017800" y="5411880"/>
              <a:ext cx="66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09E+06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286080" y="5411880"/>
              <a:ext cx="66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10E+06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557600" y="5411880"/>
              <a:ext cx="66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11E+06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5824440" y="5411880"/>
              <a:ext cx="66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12E+06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7092720" y="5411880"/>
              <a:ext cx="66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13E+06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8361360" y="5411880"/>
              <a:ext cx="6606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1.14E+06</a:t>
              </a:r>
              <a:endParaRPr b="0" lang="en-US" sz="12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189600" y="5837400"/>
              <a:ext cx="27712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osition along backbone sequence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 rot="16200000">
              <a:off x="-1299600" y="3247200"/>
              <a:ext cx="31179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Phylogenetic congruence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 rot="16200000">
              <a:off x="-1301760" y="3249720"/>
              <a:ext cx="37321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(in standard deviation units)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057320" y="2114640"/>
              <a:ext cx="7238880" cy="0"/>
            </a:xfrm>
            <a:prstGeom prst="line">
              <a:avLst/>
            </a:prstGeom>
            <a:ln w="223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060560" y="2643120"/>
              <a:ext cx="7238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054080" y="1587600"/>
              <a:ext cx="72388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6307200" y="4068720"/>
              <a:ext cx="182520" cy="1193760"/>
            </a:xfrm>
            <a:prstGeom prst="downArrow">
              <a:avLst>
                <a:gd name="adj1" fmla="val 33750"/>
                <a:gd name="adj2" fmla="val 109885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955880" y="2544840"/>
              <a:ext cx="5089320" cy="201600"/>
            </a:xfrm>
            <a:prstGeom prst="leftRightArrow">
              <a:avLst>
                <a:gd name="adj1" fmla="val 25620"/>
                <a:gd name="adj2" fmla="val 124470"/>
              </a:avLst>
            </a:prstGeom>
            <a:solidFill>
              <a:srgbClr val="99cc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040" bIns="504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884920" y="3664080"/>
              <a:ext cx="8575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rfb</a:t>
              </a:r>
              <a:r>
                <a:rPr b="0" lang="fr-FR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locus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306600" y="2209680"/>
              <a:ext cx="3170520" cy="30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694400" y="4062240"/>
              <a:ext cx="182520" cy="1194120"/>
            </a:xfrm>
            <a:prstGeom prst="downArrow">
              <a:avLst>
                <a:gd name="adj1" fmla="val 33750"/>
                <a:gd name="adj2" fmla="val 109918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182760" y="4062240"/>
              <a:ext cx="182880" cy="1194120"/>
            </a:xfrm>
            <a:prstGeom prst="downArrow">
              <a:avLst>
                <a:gd name="adj1" fmla="val 33750"/>
                <a:gd name="adj2" fmla="val 109702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021040" y="4062240"/>
              <a:ext cx="182520" cy="1194120"/>
            </a:xfrm>
            <a:prstGeom prst="downArrow">
              <a:avLst>
                <a:gd name="adj1" fmla="val 33750"/>
                <a:gd name="adj2" fmla="val 109918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535120" y="4062240"/>
              <a:ext cx="182520" cy="1194120"/>
            </a:xfrm>
            <a:prstGeom prst="downArrow">
              <a:avLst>
                <a:gd name="adj1" fmla="val 33750"/>
                <a:gd name="adj2" fmla="val 109918"/>
              </a:avLst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573440" y="3664080"/>
              <a:ext cx="478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HPI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427120" y="3664080"/>
              <a:ext cx="438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liC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919600" y="3664080"/>
              <a:ext cx="9154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fr-FR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fli</a:t>
              </a:r>
              <a:r>
                <a:rPr b="0" lang="fr-FR" sz="14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operon</a:t>
              </a:r>
              <a:endParaRPr b="0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2-13T18:48:24Z</dcterms:created>
  <dc:creator>Erick DENAMUR</dc:creator>
  <dc:description/>
  <dc:language>en-US</dc:language>
  <cp:lastModifiedBy>Erick DENAMUR</cp:lastModifiedBy>
  <dcterms:modified xsi:type="dcterms:W3CDTF">2008-12-13T18:49:05Z</dcterms:modified>
  <cp:revision>1</cp:revision>
  <dc:subject/>
  <dc:title>Présentation PowerPoint</dc:title>
</cp:coreProperties>
</file>